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7"/>
    <p:restoredTop sz="94619"/>
  </p:normalViewPr>
  <p:slideViewPr>
    <p:cSldViewPr snapToGrid="0" snapToObjects="1">
      <p:cViewPr>
        <p:scale>
          <a:sx n="100" d="100"/>
          <a:sy n="100" d="100"/>
        </p:scale>
        <p:origin x="-948" y="-2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F8CF-AAFD-C948-843D-667026A62708}" type="datetimeFigureOut">
              <a:rPr lang="en-US" smtClean="0"/>
              <a:t>10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25690-1E8B-4C4E-90C2-444F0E957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989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F8CF-AAFD-C948-843D-667026A62708}" type="datetimeFigureOut">
              <a:rPr lang="en-US" smtClean="0"/>
              <a:t>10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25690-1E8B-4C4E-90C2-444F0E957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643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F8CF-AAFD-C948-843D-667026A62708}" type="datetimeFigureOut">
              <a:rPr lang="en-US" smtClean="0"/>
              <a:t>10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25690-1E8B-4C4E-90C2-444F0E957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8135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F8CF-AAFD-C948-843D-667026A62708}" type="datetimeFigureOut">
              <a:rPr lang="en-US" smtClean="0"/>
              <a:t>10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25690-1E8B-4C4E-90C2-444F0E957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77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F8CF-AAFD-C948-843D-667026A62708}" type="datetimeFigureOut">
              <a:rPr lang="en-US" smtClean="0"/>
              <a:t>10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25690-1E8B-4C4E-90C2-444F0E957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83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F8CF-AAFD-C948-843D-667026A62708}" type="datetimeFigureOut">
              <a:rPr lang="en-US" smtClean="0"/>
              <a:t>10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25690-1E8B-4C4E-90C2-444F0E957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656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F8CF-AAFD-C948-843D-667026A62708}" type="datetimeFigureOut">
              <a:rPr lang="en-US" smtClean="0"/>
              <a:t>10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25690-1E8B-4C4E-90C2-444F0E957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652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F8CF-AAFD-C948-843D-667026A62708}" type="datetimeFigureOut">
              <a:rPr lang="en-US" smtClean="0"/>
              <a:t>10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25690-1E8B-4C4E-90C2-444F0E957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631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F8CF-AAFD-C948-843D-667026A62708}" type="datetimeFigureOut">
              <a:rPr lang="en-US" smtClean="0"/>
              <a:t>10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25690-1E8B-4C4E-90C2-444F0E957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5779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F8CF-AAFD-C948-843D-667026A62708}" type="datetimeFigureOut">
              <a:rPr lang="en-US" smtClean="0"/>
              <a:t>10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25690-1E8B-4C4E-90C2-444F0E957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147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F8CF-AAFD-C948-843D-667026A62708}" type="datetimeFigureOut">
              <a:rPr lang="en-US" smtClean="0"/>
              <a:t>10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25690-1E8B-4C4E-90C2-444F0E957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3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9F8CF-AAFD-C948-843D-667026A62708}" type="datetimeFigureOut">
              <a:rPr lang="en-US" smtClean="0"/>
              <a:t>10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925690-1E8B-4C4E-90C2-444F0E957C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360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5511909"/>
              </p:ext>
            </p:extLst>
          </p:nvPr>
        </p:nvGraphicFramePr>
        <p:xfrm>
          <a:off x="2170708" y="1179444"/>
          <a:ext cx="9318927" cy="5512906"/>
        </p:xfrm>
        <a:graphic>
          <a:graphicData uri="http://schemas.openxmlformats.org/drawingml/2006/table">
            <a:tbl>
              <a:tblPr firstRow="1" firstCol="1" bandRow="1">
                <a:tableStyleId>{0505E3EF-67EA-436B-97B2-0124C06EBD24}</a:tableStyleId>
              </a:tblPr>
              <a:tblGrid>
                <a:gridCol w="869333"/>
                <a:gridCol w="1112944"/>
                <a:gridCol w="1384998"/>
                <a:gridCol w="667766"/>
                <a:gridCol w="729597"/>
                <a:gridCol w="1298435"/>
                <a:gridCol w="3255854"/>
              </a:tblGrid>
              <a:tr h="50971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Samples</a:t>
                      </a:r>
                      <a:endParaRPr lang="en-US" sz="1000" dirty="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Activation method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Feeder cells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Duration (days)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Total cells tested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Detection Method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Subjects: IUPM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</a:tr>
              <a:tr h="97088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rCD4 T cells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HA-irradiated PBMCs (10-fold excess)+IL-2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-4x10</a:t>
                      </a:r>
                      <a:r>
                        <a:rPr lang="en-US" sz="900" baseline="30000">
                          <a:effectLst/>
                        </a:rPr>
                        <a:t>6</a:t>
                      </a:r>
                      <a:r>
                        <a:rPr lang="en-US" sz="900">
                          <a:effectLst/>
                        </a:rPr>
                        <a:t> CD8dPBMCs activated with PHA (1 or more donors)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4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2.5x10</a:t>
                      </a:r>
                      <a:r>
                        <a:rPr lang="en-US" sz="900" baseline="30000">
                          <a:effectLst/>
                        </a:rPr>
                        <a:t>6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24 ELISA/TZM-bl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u="sng" dirty="0">
                          <a:effectLst/>
                        </a:rPr>
                        <a:t>Acute:</a:t>
                      </a:r>
                      <a:r>
                        <a:rPr lang="en-US" sz="900" dirty="0">
                          <a:effectLst/>
                        </a:rPr>
                        <a:t> Range 0.03-3 (n=62) [15], mean=0.28 (n=9) [11], median ~0.25 (n=8) [45]</a:t>
                      </a:r>
                      <a:br>
                        <a:rPr lang="en-US" sz="900" dirty="0">
                          <a:effectLst/>
                        </a:rPr>
                      </a:br>
                      <a:r>
                        <a:rPr lang="en-US" sz="900" u="sng" dirty="0">
                          <a:effectLst/>
                        </a:rPr>
                        <a:t>Chronic</a:t>
                      </a:r>
                      <a:r>
                        <a:rPr lang="en-US" sz="900" dirty="0">
                          <a:effectLst/>
                        </a:rPr>
                        <a:t> : mean=0.97 (n=20) [11], median ~0.9 (n=11) [45], range ~0.1-2 (n=10) [36]</a:t>
                      </a:r>
                      <a:endParaRPr lang="en-US" sz="1000" dirty="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</a:tr>
              <a:tr h="67961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rCD4 or CD4 T cells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HA-irradiated PBMCs (10-fold excess)+IL-2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-4x10</a:t>
                      </a:r>
                      <a:r>
                        <a:rPr lang="en-US" sz="900" baseline="30000">
                          <a:effectLst/>
                        </a:rPr>
                        <a:t>6</a:t>
                      </a:r>
                      <a:r>
                        <a:rPr lang="en-US" sz="900">
                          <a:effectLst/>
                        </a:rPr>
                        <a:t> CD8dPBMCs activated with 3x3 method</a:t>
                      </a:r>
                      <a:r>
                        <a:rPr lang="en-US" sz="900" baseline="30000">
                          <a:effectLst/>
                        </a:rPr>
                        <a:t>#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4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.5-25x10</a:t>
                      </a:r>
                      <a:r>
                        <a:rPr lang="en-US" sz="900" baseline="30000">
                          <a:effectLst/>
                        </a:rPr>
                        <a:t>6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24 ELISA or </a:t>
                      </a:r>
                      <a:endParaRPr lang="en-US" sz="1000">
                        <a:effectLst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TZM-bl 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u="sng">
                          <a:effectLst/>
                        </a:rPr>
                        <a:t>Chronic:</a:t>
                      </a:r>
                      <a:r>
                        <a:rPr lang="en-US" sz="900">
                          <a:effectLst/>
                        </a:rPr>
                        <a:t> Range 0.15-4 (n=6) [46] , Median 0.42 IQR [0.23-8.29] (n=10) and Median 1.61 IQR [0.23-4.45] (n=10) [47] 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</a:tr>
              <a:tr h="51898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rCD4 T cells + Int &amp; RT inhibitor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HA-irradiated PBMCs (5-fold excess) 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x10</a:t>
                      </a:r>
                      <a:r>
                        <a:rPr lang="en-US" sz="900" baseline="30000">
                          <a:effectLst/>
                        </a:rPr>
                        <a:t>6</a:t>
                      </a:r>
                      <a:r>
                        <a:rPr lang="en-US" sz="900">
                          <a:effectLst/>
                        </a:rPr>
                        <a:t> CD8dPBMCs activated with PHA+ IL-2 (1 donor)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1-28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&gt;90x10</a:t>
                      </a:r>
                      <a:r>
                        <a:rPr lang="en-US" sz="900" baseline="30000">
                          <a:effectLst/>
                        </a:rPr>
                        <a:t>6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24 ELISA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u="sng">
                          <a:effectLst/>
                        </a:rPr>
                        <a:t>Chronic: </a:t>
                      </a:r>
                      <a:r>
                        <a:rPr lang="en-US" sz="900">
                          <a:effectLst/>
                        </a:rPr>
                        <a:t>Range 0.06-0.44 (n=5) [48], median 0.19 IQR[0.07-0.41] (n=13) [49]</a:t>
                      </a:r>
                      <a:endParaRPr lang="en-US" sz="1000">
                        <a:effectLst/>
                      </a:endParaRP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u="sng">
                          <a:effectLst/>
                        </a:rPr>
                        <a:t>Acute/Chronic:</a:t>
                      </a:r>
                      <a:r>
                        <a:rPr lang="en-US" sz="900">
                          <a:effectLst/>
                        </a:rPr>
                        <a:t> Median 0.42 range (0.01-11) [39]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b"/>
                </a:tc>
              </a:tr>
              <a:tr h="51898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CD8dPBMCs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Immobilized anti-CD3/CD28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5x 10</a:t>
                      </a:r>
                      <a:r>
                        <a:rPr lang="en-US" sz="900" baseline="30000">
                          <a:effectLst/>
                        </a:rPr>
                        <a:t>6</a:t>
                      </a:r>
                      <a:r>
                        <a:rPr lang="en-US" sz="900">
                          <a:effectLst/>
                        </a:rPr>
                        <a:t> CD8dPBMCs activated with PHA  (4 donors)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1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2-40x10</a:t>
                      </a:r>
                      <a:r>
                        <a:rPr lang="en-US" sz="900" baseline="30000">
                          <a:effectLst/>
                        </a:rPr>
                        <a:t>6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24 ELISA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u="sng">
                          <a:effectLst/>
                        </a:rPr>
                        <a:t>Acute</a:t>
                      </a:r>
                      <a:r>
                        <a:rPr lang="en-US" sz="900">
                          <a:effectLst/>
                        </a:rPr>
                        <a:t>: Median 0.033 (n=17) [10]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</a:tr>
              <a:tr h="84952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rCD4 T cells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HA-irradiated PBMCs (10-fold excess) + IL-2 + T-cell growth factor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.5-10x10</a:t>
                      </a:r>
                      <a:r>
                        <a:rPr lang="en-US" sz="900" baseline="30000">
                          <a:effectLst/>
                        </a:rPr>
                        <a:t>6</a:t>
                      </a:r>
                      <a:r>
                        <a:rPr lang="en-US" sz="900">
                          <a:effectLst/>
                        </a:rPr>
                        <a:t> MOLT-4/CCR5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4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.5x10</a:t>
                      </a:r>
                      <a:r>
                        <a:rPr lang="en-US" sz="900" baseline="30000">
                          <a:effectLst/>
                        </a:rPr>
                        <a:t>6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RT-PCR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u="sng">
                          <a:effectLst/>
                        </a:rPr>
                        <a:t>Chronic</a:t>
                      </a:r>
                      <a:r>
                        <a:rPr lang="en-US" sz="900">
                          <a:effectLst/>
                        </a:rPr>
                        <a:t>: median 0.51 IQR [0-1.1] [19], range 0.033 to 16.248 (n=9) [50]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</a:tr>
              <a:tr h="59331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rCD4 T cells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HA-irradiated PBMCs (10-fold excess) +IL-2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SupT1-CCR5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3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Average 3.59×10</a:t>
                      </a:r>
                      <a:r>
                        <a:rPr lang="en-US" sz="900" baseline="30000">
                          <a:effectLst/>
                        </a:rPr>
                        <a:t>7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24 ELISA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u="sng">
                          <a:effectLst/>
                        </a:rPr>
                        <a:t>Chronic</a:t>
                      </a:r>
                      <a:r>
                        <a:rPr lang="en-US" sz="900">
                          <a:effectLst/>
                        </a:rPr>
                        <a:t>: median 0.2 IQR[0.05-0.5] (n=20) [20] 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</a:tr>
              <a:tr h="34599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CD4 T cells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Immobilized anti-CD3/CD28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2x10</a:t>
                      </a:r>
                      <a:r>
                        <a:rPr lang="en-US" sz="900" baseline="30000">
                          <a:effectLst/>
                        </a:rPr>
                        <a:t>6</a:t>
                      </a:r>
                      <a:r>
                        <a:rPr lang="en-US" sz="900">
                          <a:effectLst/>
                        </a:rPr>
                        <a:t> MOLT-4/CCR5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4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9x10</a:t>
                      </a:r>
                      <a:r>
                        <a:rPr lang="en-US" sz="900" baseline="30000">
                          <a:effectLst/>
                        </a:rPr>
                        <a:t>6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RT-PCR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u="sng">
                          <a:effectLst/>
                        </a:rPr>
                        <a:t>Chronic: </a:t>
                      </a:r>
                      <a:r>
                        <a:rPr lang="en-US" sz="900">
                          <a:effectLst/>
                        </a:rPr>
                        <a:t>Median Cumulative 5.8 IQR [2.8-11.4]  or day14: 3.3 IQR [1.9-6.2] (n=32) (This study)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</a:tr>
              <a:tr h="202267">
                <a:tc gridSpan="5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</a:rPr>
                        <a:t>rCD4 T cells = Resting CD4 T cells; CD8dPBMCs = CD8 depleted PBMCs</a:t>
                      </a:r>
                      <a:endParaRPr lang="en-US" sz="100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mbria" charset="0"/>
                      </a:endParaRPr>
                    </a:p>
                  </a:txBody>
                  <a:tcPr marL="57733" marR="57733" marT="0" marB="0" anchor="b"/>
                </a:tc>
                <a:tc>
                  <a:txBody>
                    <a:bodyPr/>
                    <a:lstStyle/>
                    <a:p>
                      <a:pPr algn="l"/>
                      <a:endParaRPr lang="en-US" sz="1000">
                        <a:effectLst/>
                        <a:latin typeface="Cambria" charset="0"/>
                      </a:endParaRPr>
                    </a:p>
                  </a:txBody>
                  <a:tcPr marL="57733" marR="57733" marT="0" marB="0" anchor="b"/>
                </a:tc>
              </a:tr>
              <a:tr h="323628">
                <a:tc gridSpan="7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aseline="30000" dirty="0">
                          <a:effectLst/>
                        </a:rPr>
                        <a:t>#</a:t>
                      </a:r>
                      <a:r>
                        <a:rPr lang="en-US" sz="800" dirty="0">
                          <a:effectLst/>
                        </a:rPr>
                        <a:t>3x3 method = 3 stimulation conditions: low-dose PHA (0.5 µg/ml) and high-dose PHA (5 µg/ml) or plate bound anti-CD3 (OKT3). After 72h, cells from three different conditions are pooled</a:t>
                      </a:r>
                      <a:endParaRPr lang="en-US" sz="1000" dirty="0"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57733" marR="57733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2170113" y="463344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x-none" altLang="x-none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rPr>
              <a:t>Supplementary Table 1: Summary of some relevant papers performing QVOA </a:t>
            </a:r>
          </a:p>
        </p:txBody>
      </p:sp>
    </p:spTree>
    <p:extLst>
      <p:ext uri="{BB962C8B-B14F-4D97-AF65-F5344CB8AC3E}">
        <p14:creationId xmlns:p14="http://schemas.microsoft.com/office/powerpoint/2010/main" val="16258352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81000" y="508000"/>
            <a:ext cx="11341100" cy="5678478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4400" b="1" dirty="0"/>
              <a:t>References</a:t>
            </a:r>
            <a:endParaRPr lang="en-IN" sz="4400" dirty="0"/>
          </a:p>
          <a:p>
            <a:endParaRPr lang="en-US" dirty="0"/>
          </a:p>
          <a:p>
            <a:r>
              <a:rPr lang="en-US" dirty="0"/>
              <a:t>45.	</a:t>
            </a:r>
            <a:r>
              <a:rPr lang="en-US" dirty="0" err="1"/>
              <a:t>Buzon</a:t>
            </a:r>
            <a:r>
              <a:rPr lang="en-US" dirty="0"/>
              <a:t> MJ, Martin-</a:t>
            </a:r>
            <a:r>
              <a:rPr lang="en-US" dirty="0" err="1"/>
              <a:t>Gayo</a:t>
            </a:r>
            <a:r>
              <a:rPr lang="en-US" dirty="0"/>
              <a:t> E, </a:t>
            </a:r>
            <a:r>
              <a:rPr lang="en-US" dirty="0" err="1"/>
              <a:t>Pereyra</a:t>
            </a:r>
            <a:r>
              <a:rPr lang="en-US" dirty="0"/>
              <a:t> F, Ouyang Z, Sun H, Li JZ, et al. Long-term Antiretroviral Treatment Initiated in Primary HIV-1 Infection Affects the Size, Composition and Decay Kinetics of the Reservoir of HIV-1 Infected CD4 T Cells. Journal of virology. 2014 Jun 25. </a:t>
            </a:r>
          </a:p>
          <a:p>
            <a:r>
              <a:rPr lang="en-US" dirty="0"/>
              <a:t>46.	</a:t>
            </a:r>
            <a:r>
              <a:rPr lang="en-US" dirty="0" err="1"/>
              <a:t>Puertas</a:t>
            </a:r>
            <a:r>
              <a:rPr lang="en-US" dirty="0"/>
              <a:t> MC, Salgado M, </a:t>
            </a:r>
            <a:r>
              <a:rPr lang="en-US" dirty="0" err="1"/>
              <a:t>Morón</a:t>
            </a:r>
            <a:r>
              <a:rPr lang="en-US" dirty="0"/>
              <a:t>-López S, </a:t>
            </a:r>
            <a:r>
              <a:rPr lang="en-US" dirty="0" err="1"/>
              <a:t>Ouchi</a:t>
            </a:r>
            <a:r>
              <a:rPr lang="en-US" dirty="0"/>
              <a:t> D, Muñoz-Moreno JA, Moltó J, et al. Effect of lithium on HIV-1 expression and </a:t>
            </a:r>
            <a:r>
              <a:rPr lang="en-US" dirty="0" err="1"/>
              <a:t>proviral</a:t>
            </a:r>
            <a:r>
              <a:rPr lang="en-US" dirty="0"/>
              <a:t> reservoir size in the CD4+ T cells of antiretroviral therapy suppressed patients. AIDS. 2014 Sep;28(14):2157–9.</a:t>
            </a:r>
          </a:p>
          <a:p>
            <a:r>
              <a:rPr lang="en-US" dirty="0"/>
              <a:t>47.	</a:t>
            </a:r>
            <a:r>
              <a:rPr lang="en-US" dirty="0" err="1"/>
              <a:t>Morón</a:t>
            </a:r>
            <a:r>
              <a:rPr lang="en-US" dirty="0"/>
              <a:t>-López S, Gómez-</a:t>
            </a:r>
            <a:r>
              <a:rPr lang="en-US" dirty="0" err="1"/>
              <a:t>Mora</a:t>
            </a:r>
            <a:r>
              <a:rPr lang="en-US" dirty="0"/>
              <a:t> E, Salgado M, </a:t>
            </a:r>
            <a:r>
              <a:rPr lang="en-US" dirty="0" err="1"/>
              <a:t>Ouchi</a:t>
            </a:r>
            <a:r>
              <a:rPr lang="en-US" dirty="0"/>
              <a:t> D, </a:t>
            </a:r>
            <a:r>
              <a:rPr lang="en-US" dirty="0" err="1"/>
              <a:t>Puertas</a:t>
            </a:r>
            <a:r>
              <a:rPr lang="en-US" dirty="0"/>
              <a:t> MC, </a:t>
            </a:r>
            <a:r>
              <a:rPr lang="en-US" dirty="0" err="1"/>
              <a:t>Urrea</a:t>
            </a:r>
            <a:r>
              <a:rPr lang="en-US" dirty="0"/>
              <a:t> V, et al. Short-term treatment with IFNα diminishes expression of HIV-1 and reduces CD4+ T-cell activation in HIV/HCV-</a:t>
            </a:r>
            <a:r>
              <a:rPr lang="en-US" dirty="0" err="1"/>
              <a:t>coinfected</a:t>
            </a:r>
            <a:r>
              <a:rPr lang="en-US" dirty="0"/>
              <a:t> patients on antiretroviral therapy. J Infect Dis. 2015 Nov 1. </a:t>
            </a:r>
          </a:p>
          <a:p>
            <a:r>
              <a:rPr lang="en-US" dirty="0"/>
              <a:t>48.	</a:t>
            </a:r>
            <a:r>
              <a:rPr lang="en-US" dirty="0" err="1"/>
              <a:t>Ylisastigui</a:t>
            </a:r>
            <a:r>
              <a:rPr lang="en-US" dirty="0"/>
              <a:t> L, </a:t>
            </a:r>
            <a:r>
              <a:rPr lang="en-US" dirty="0" err="1"/>
              <a:t>Archin</a:t>
            </a:r>
            <a:r>
              <a:rPr lang="en-US" dirty="0"/>
              <a:t> NM, </a:t>
            </a:r>
            <a:r>
              <a:rPr lang="en-US" dirty="0" err="1"/>
              <a:t>Lehrman</a:t>
            </a:r>
            <a:r>
              <a:rPr lang="en-US" dirty="0"/>
              <a:t> G, Bosch RJ, Margolis DM. Coaxing HIV-1 from resting CD4 T cells: histone </a:t>
            </a:r>
            <a:r>
              <a:rPr lang="en-US" dirty="0" err="1"/>
              <a:t>deacetylase</a:t>
            </a:r>
            <a:r>
              <a:rPr lang="en-US" dirty="0"/>
              <a:t> inhibition allows latent viral expression. AIDS. 2004 May 21;18(8):1101–8. </a:t>
            </a:r>
          </a:p>
          <a:p>
            <a:r>
              <a:rPr lang="en-US" dirty="0"/>
              <a:t>49.	</a:t>
            </a:r>
            <a:r>
              <a:rPr lang="en-US" dirty="0" err="1"/>
              <a:t>Archin</a:t>
            </a:r>
            <a:r>
              <a:rPr lang="en-US" dirty="0"/>
              <a:t> NM, Cheema M, Parker D, </a:t>
            </a:r>
            <a:r>
              <a:rPr lang="en-US" dirty="0" err="1"/>
              <a:t>Wiegand</a:t>
            </a:r>
            <a:r>
              <a:rPr lang="en-US" dirty="0"/>
              <a:t> A, Bosch RJ, Coffin JM, et al. Antiretroviral intensification and </a:t>
            </a:r>
            <a:r>
              <a:rPr lang="en-US" dirty="0" err="1"/>
              <a:t>valproic</a:t>
            </a:r>
            <a:r>
              <a:rPr lang="en-US" dirty="0"/>
              <a:t> acid lack sustained effect on residual HIV-1 </a:t>
            </a:r>
            <a:r>
              <a:rPr lang="en-US" dirty="0" err="1"/>
              <a:t>viremia</a:t>
            </a:r>
            <a:r>
              <a:rPr lang="en-US" dirty="0"/>
              <a:t> or resting CD4+ cell infection. </a:t>
            </a:r>
            <a:r>
              <a:rPr lang="en-US" dirty="0" err="1"/>
              <a:t>Plos</a:t>
            </a:r>
            <a:r>
              <a:rPr lang="en-US" dirty="0"/>
              <a:t> One. 2010;5(2):e9390. </a:t>
            </a:r>
          </a:p>
          <a:p>
            <a:r>
              <a:rPr lang="en-US" dirty="0"/>
              <a:t>50.	</a:t>
            </a:r>
            <a:r>
              <a:rPr lang="en-US" dirty="0" err="1"/>
              <a:t>Salantes</a:t>
            </a:r>
            <a:r>
              <a:rPr lang="en-US" dirty="0"/>
              <a:t> DB, Zheng Y, </a:t>
            </a:r>
            <a:r>
              <a:rPr lang="en-US" dirty="0" err="1"/>
              <a:t>Mampe</a:t>
            </a:r>
            <a:r>
              <a:rPr lang="en-US" dirty="0"/>
              <a:t> F, Srivastava T, Beg S, Lai J, et al. HIV-1 latent reservoir size and diversity are stable following brief treatment interruption. J </a:t>
            </a:r>
            <a:r>
              <a:rPr lang="en-US" dirty="0" err="1"/>
              <a:t>Clin</a:t>
            </a:r>
            <a:r>
              <a:rPr lang="en-US" dirty="0"/>
              <a:t> Invest. 2018 Jul 2;128(7):3102–15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51303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384</Words>
  <Application>Microsoft Office PowerPoint</Application>
  <PresentationFormat>Custom</PresentationFormat>
  <Paragraphs>69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uglas Richman</dc:creator>
  <cp:lastModifiedBy>203843</cp:lastModifiedBy>
  <cp:revision>5</cp:revision>
  <dcterms:created xsi:type="dcterms:W3CDTF">2018-09-16T21:15:39Z</dcterms:created>
  <dcterms:modified xsi:type="dcterms:W3CDTF">2018-10-10T11:36:09Z</dcterms:modified>
</cp:coreProperties>
</file>